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60" r:id="rId4"/>
    <p:sldId id="262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48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CA468-FDDA-4B44-97F5-F2CBA133DC3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E00B5-5A5F-448D-9A4E-F30576E130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32832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CA468-FDDA-4B44-97F5-F2CBA133DC3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E00B5-5A5F-448D-9A4E-F30576E130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06610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CA468-FDDA-4B44-97F5-F2CBA133DC3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E00B5-5A5F-448D-9A4E-F30576E130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55819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CA468-FDDA-4B44-97F5-F2CBA133DC3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E00B5-5A5F-448D-9A4E-F30576E130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5281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CA468-FDDA-4B44-97F5-F2CBA133DC3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E00B5-5A5F-448D-9A4E-F30576E130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0616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CA468-FDDA-4B44-97F5-F2CBA133DC3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E00B5-5A5F-448D-9A4E-F30576E130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1864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CA468-FDDA-4B44-97F5-F2CBA133DC3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E00B5-5A5F-448D-9A4E-F30576E130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2799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CA468-FDDA-4B44-97F5-F2CBA133DC3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E00B5-5A5F-448D-9A4E-F30576E130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3919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CA468-FDDA-4B44-97F5-F2CBA133DC3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E00B5-5A5F-448D-9A4E-F30576E130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41931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CA468-FDDA-4B44-97F5-F2CBA133DC3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E00B5-5A5F-448D-9A4E-F30576E130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21815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4CA468-FDDA-4B44-97F5-F2CBA133DC3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E00B5-5A5F-448D-9A4E-F30576E130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1955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4CA468-FDDA-4B44-97F5-F2CBA133DC36}" type="datetimeFigureOut">
              <a:rPr lang="zh-CN" altLang="en-US" smtClean="0"/>
              <a:t>2020-10-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BE00B5-5A5F-448D-9A4E-F30576E1304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8424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tiff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35" t="25694" r="42199" b="57639"/>
          <a:stretch/>
        </p:blipFill>
        <p:spPr>
          <a:xfrm>
            <a:off x="3221825" y="2245657"/>
            <a:ext cx="2393577" cy="8606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29" t="26991" r="30474" b="58849"/>
          <a:stretch/>
        </p:blipFill>
        <p:spPr>
          <a:xfrm>
            <a:off x="3221824" y="3173505"/>
            <a:ext cx="2393577" cy="6589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文本框 7"/>
          <p:cNvSpPr txBox="1"/>
          <p:nvPr/>
        </p:nvSpPr>
        <p:spPr>
          <a:xfrm>
            <a:off x="5601954" y="2585890"/>
            <a:ext cx="686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G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5619884" y="3316511"/>
            <a:ext cx="17940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 (Input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603262" y="2487705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3100805" y="2649065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2621192" y="2734234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3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3" name="直接连接符 12"/>
          <p:cNvCxnSpPr/>
          <p:nvPr/>
        </p:nvCxnSpPr>
        <p:spPr>
          <a:xfrm>
            <a:off x="3118735" y="2895594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2612228" y="3290044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5" name="直接连接符 14"/>
          <p:cNvCxnSpPr/>
          <p:nvPr/>
        </p:nvCxnSpPr>
        <p:spPr>
          <a:xfrm>
            <a:off x="3096324" y="3451404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35" t="19202" r="34302" b="67754"/>
          <a:stretch/>
        </p:blipFill>
        <p:spPr>
          <a:xfrm>
            <a:off x="3231218" y="4491320"/>
            <a:ext cx="2384182" cy="61856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文本框 18"/>
          <p:cNvSpPr txBox="1"/>
          <p:nvPr/>
        </p:nvSpPr>
        <p:spPr>
          <a:xfrm>
            <a:off x="5651261" y="4652247"/>
            <a:ext cx="22349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 (Pull-dow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2616711" y="4679568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3" name="直接连接符 22"/>
          <p:cNvCxnSpPr/>
          <p:nvPr/>
        </p:nvCxnSpPr>
        <p:spPr>
          <a:xfrm>
            <a:off x="3100807" y="4840928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2554942" y="1864392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 (min)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3592049" y="1849003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4013389" y="1849003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4380941" y="1849003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4708152" y="1849003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5125009" y="1849003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3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3551708" y="1466303"/>
            <a:ext cx="20281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PEX2-FLAG-STS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1" name="直接连接符 30"/>
          <p:cNvCxnSpPr/>
          <p:nvPr/>
        </p:nvCxnSpPr>
        <p:spPr>
          <a:xfrm>
            <a:off x="3551708" y="1811675"/>
            <a:ext cx="19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3" name="图片 3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21824" y="3931299"/>
            <a:ext cx="2394000" cy="4667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4" name="文本框 33"/>
          <p:cNvSpPr txBox="1"/>
          <p:nvPr/>
        </p:nvSpPr>
        <p:spPr>
          <a:xfrm>
            <a:off x="2630158" y="3913089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3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5" name="直接连接符 34"/>
          <p:cNvCxnSpPr/>
          <p:nvPr/>
        </p:nvCxnSpPr>
        <p:spPr>
          <a:xfrm>
            <a:off x="3114254" y="4074449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35"/>
          <p:cNvSpPr txBox="1"/>
          <p:nvPr/>
        </p:nvSpPr>
        <p:spPr>
          <a:xfrm>
            <a:off x="2621194" y="4105830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7" name="直接连接符 36"/>
          <p:cNvCxnSpPr/>
          <p:nvPr/>
        </p:nvCxnSpPr>
        <p:spPr>
          <a:xfrm>
            <a:off x="3105290" y="4267190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文本框 38"/>
          <p:cNvSpPr txBox="1"/>
          <p:nvPr/>
        </p:nvSpPr>
        <p:spPr>
          <a:xfrm>
            <a:off x="5642297" y="4024721"/>
            <a:ext cx="2380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CD2AP (Pull-dow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363071" y="564776"/>
            <a:ext cx="3339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8d. Replicate 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6046449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63071" y="564776"/>
            <a:ext cx="3339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8d. Replicate 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73" t="28416" r="43902" b="57296"/>
          <a:stretch/>
        </p:blipFill>
        <p:spPr>
          <a:xfrm>
            <a:off x="3132462" y="2971804"/>
            <a:ext cx="2077404" cy="63201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1" name="文本框 20"/>
          <p:cNvSpPr txBox="1"/>
          <p:nvPr/>
        </p:nvSpPr>
        <p:spPr>
          <a:xfrm>
            <a:off x="5285078" y="2626235"/>
            <a:ext cx="686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G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5289561" y="3087916"/>
            <a:ext cx="17716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FLAG (Input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2164978" y="1541669"/>
            <a:ext cx="11320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 (mi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3228979" y="152628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3650319" y="152628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4044765" y="152628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4385423" y="1526280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4802280" y="1526280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3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3175191" y="1143580"/>
            <a:ext cx="20281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PEX2-FLAG-STS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0" name="直接连接符 29"/>
          <p:cNvCxnSpPr/>
          <p:nvPr/>
        </p:nvCxnSpPr>
        <p:spPr>
          <a:xfrm>
            <a:off x="3188638" y="1488952"/>
            <a:ext cx="19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1" name="图片 3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75" t="42448" r="29942" b="44531"/>
          <a:stretch/>
        </p:blipFill>
        <p:spPr>
          <a:xfrm>
            <a:off x="3132461" y="3665332"/>
            <a:ext cx="2077405" cy="67235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39018" y="4397191"/>
            <a:ext cx="2070848" cy="64505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3" name="文本框 32"/>
          <p:cNvSpPr txBox="1"/>
          <p:nvPr/>
        </p:nvSpPr>
        <p:spPr>
          <a:xfrm>
            <a:off x="5280597" y="4517781"/>
            <a:ext cx="22124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FLAG (Pull-dow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5285080" y="3823020"/>
            <a:ext cx="23583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CD2AP (Pull-dow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5"/>
          <a:srcRect b="33873"/>
          <a:stretch/>
        </p:blipFill>
        <p:spPr>
          <a:xfrm>
            <a:off x="3135329" y="1924340"/>
            <a:ext cx="2074537" cy="980225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8113862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/>
          <a:srcRect b="37302"/>
          <a:stretch/>
        </p:blipFill>
        <p:spPr>
          <a:xfrm>
            <a:off x="2922234" y="2259105"/>
            <a:ext cx="1820356" cy="10623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/>
          <a:srcRect l="4939" t="5128" b="-1"/>
          <a:stretch/>
        </p:blipFill>
        <p:spPr>
          <a:xfrm>
            <a:off x="2922234" y="3375212"/>
            <a:ext cx="1820355" cy="4975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22234" y="3935353"/>
            <a:ext cx="1821600" cy="42149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68" t="36522" r="33255" b="53913"/>
          <a:stretch/>
        </p:blipFill>
        <p:spPr>
          <a:xfrm>
            <a:off x="2922234" y="4405999"/>
            <a:ext cx="1821600" cy="3777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文本框 8"/>
          <p:cNvSpPr txBox="1"/>
          <p:nvPr/>
        </p:nvSpPr>
        <p:spPr>
          <a:xfrm>
            <a:off x="4760259" y="2605756"/>
            <a:ext cx="622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G10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4764742" y="3484294"/>
            <a:ext cx="1566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FLAG (Input)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764742" y="4414241"/>
            <a:ext cx="19559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FLAG (Pull-down)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764742" y="3921185"/>
            <a:ext cx="20874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CD2AP (Pull-down)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936379" y="1985422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 (min)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000380" y="197003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327591" y="197003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3681696" y="197003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3968566" y="197003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4318188" y="197003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30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960039" y="1587333"/>
            <a:ext cx="18004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PEX2-FLAG-STS1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0" name="直接连接符 19"/>
          <p:cNvCxnSpPr/>
          <p:nvPr/>
        </p:nvCxnSpPr>
        <p:spPr>
          <a:xfrm>
            <a:off x="3027274" y="1932705"/>
            <a:ext cx="16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/>
        </p:nvSpPr>
        <p:spPr>
          <a:xfrm>
            <a:off x="363071" y="564776"/>
            <a:ext cx="3339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8d. Replicate 3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8809160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363071" y="564776"/>
            <a:ext cx="42049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8d. Quantification (n=3)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5984" y="2084832"/>
            <a:ext cx="6352032" cy="26883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9429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</TotalTime>
  <Words>97</Words>
  <Application>Microsoft Office PowerPoint</Application>
  <PresentationFormat>全屏显示(4:3)</PresentationFormat>
  <Paragraphs>43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Arial Unicode MS</vt:lpstr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>SUST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14</cp:revision>
  <dcterms:created xsi:type="dcterms:W3CDTF">2020-08-31T12:30:45Z</dcterms:created>
  <dcterms:modified xsi:type="dcterms:W3CDTF">2020-10-12T07:45:37Z</dcterms:modified>
</cp:coreProperties>
</file>